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2D4E0-50F3-4EEC-9285-3A26C168B5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1B75A3-F8BB-4C84-90B2-AF3CE4A6C0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EF3AD-C77B-4CFB-B54C-A4BBE53A2C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1AB83-6BE6-4D57-B032-D256C9DDBA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87025F-2886-4E7F-BD55-F76CBCEA2A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9BD4E-EAA1-420A-B27F-29C6CA2658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BA938B-CA4F-4C68-AAAF-443A106D3B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464441-F63E-4FCC-980A-47FD160EA2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B9231-29F1-4296-9378-11191B53F6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96C782-3397-47CD-84DE-EB100C5235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493398-6EC0-443A-93A5-38EF40EECE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9006D-F8EA-43DE-B247-603F50BFFE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FCAC72-3143-4A3B-B2A5-ACBE2987181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838080" y="304920"/>
            <a:ext cx="4810320" cy="53053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533520" y="5715000"/>
            <a:ext cx="5622840" cy="283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1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Dendrograms of plant MTP1 protein-coding DNA sequence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lignments using Neighbor-Joining. Numbers at nodes represent the bootstrap values obtained for the 1000 replicate analyses. Bar represents Kimura-2 parameter distance. Dendrograms were constructed using the distance method of Neighbour Joining (NJ) (Saitou and Nei, 1987), performed on a Kimura-2 parameter (pair wise distances) (Kimura, 1980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conducted using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EGA version 3.1 (Kumar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et al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, 2004)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Accessions numbers AhMTp1-7 - AJ704806, AhMTP1-6 - AJ704805, AhMTP1-4 - AJ704803, AhMTP1-3 - AJ556183, AhMTP1-5 - AJ704804, AhMTP1-2 - AJ704802, AhMTP1-1 - AJ704801, AtMTP1 - NM_180128, AlMTP1-2 - AJ704808, AlMTP1-1 - AJ704807, AsMTP1 - AY483147, TaMTP1 - AY483145, TcMTP1 - AY483146, TmMTP1 - AY483144, TgMTP1t2 - AY044454, TgMTP1t1 - AY044453, B.oleraceaMTP1 - BH596747 (TIGR database - B. oleracea sequencing project), B.junceaMTP1 – EF128447, B.campestrisMTP1 – EF128445, B.nigraMTP1 – EF128446,PopulusMTP1 - AY45045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15T20:38:22Z</dcterms:created>
  <dc:creator>dsalt</dc:creator>
  <dc:description/>
  <dc:language>en-US</dc:language>
  <cp:lastModifiedBy>kumar</cp:lastModifiedBy>
  <dcterms:modified xsi:type="dcterms:W3CDTF">2007-05-18T14:30:28Z</dcterms:modified>
  <cp:revision>5</cp:revision>
  <dc:subject/>
  <dc:title>Slide 1</dc:title>
</cp:coreProperties>
</file>